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2371" y="-8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ongh\work33\IPF.manuscript\version13\Archive11\FigureS3\Fig4C_FoldChanges\OldFigureS2\FigS2A_FoldChange\Classifier_FC_3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autoTitleDeleted val="1"/>
    <c:plotArea>
      <c:layout>
        <c:manualLayout>
          <c:layoutTarget val="inner"/>
          <c:xMode val="edge"/>
          <c:yMode val="edge"/>
          <c:x val="4.1847112860892356E-2"/>
          <c:y val="2.8252405949256338E-2"/>
          <c:w val="0.93444466316710462"/>
          <c:h val="0.9250922280548266"/>
        </c:manualLayout>
      </c:layout>
      <c:scatterChart>
        <c:scatterStyle val="lineMarker"/>
        <c:ser>
          <c:idx val="0"/>
          <c:order val="0"/>
          <c:tx>
            <c:v>UCV cohort</c:v>
          </c:tx>
          <c:spPr>
            <a:ln w="28575">
              <a:noFill/>
            </a:ln>
          </c:spPr>
          <c:marker>
            <c:symbol val="x"/>
            <c:size val="2"/>
          </c:marker>
          <c:trendline>
            <c:trendlineType val="linear"/>
            <c:dispRSqr val="1"/>
            <c:dispEq val="1"/>
            <c:trendlineLbl>
              <c:layout>
                <c:manualLayout>
                  <c:x val="-0.63942166711919934"/>
                  <c:y val="-0.12919484329164738"/>
                </c:manualLayout>
              </c:layout>
              <c:tx>
                <c:rich>
                  <a:bodyPr/>
                  <a:lstStyle/>
                  <a:p>
                    <a:pPr>
                      <a:defRPr>
                        <a:latin typeface="Times New Roman" pitchFamily="18" charset="0"/>
                        <a:cs typeface="Times New Roman" pitchFamily="18" charset="0"/>
                      </a:defRPr>
                    </a:pPr>
                    <a:r>
                      <a:rPr lang="en-US" baseline="0" dirty="0" smtClean="0"/>
                      <a:t>R² </a:t>
                    </a:r>
                    <a:r>
                      <a:rPr lang="en-US" baseline="0" dirty="0"/>
                      <a:t>= 0.86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xVal>
            <c:numRef>
              <c:f>IPF1_Classifier!$G$2:$G$119</c:f>
              <c:numCache>
                <c:formatCode>General</c:formatCode>
                <c:ptCount val="118"/>
                <c:pt idx="0">
                  <c:v>-1.9800517743541945</c:v>
                </c:pt>
                <c:pt idx="1">
                  <c:v>-1.9469720094562069</c:v>
                </c:pt>
                <c:pt idx="2">
                  <c:v>-1.9171329849815841</c:v>
                </c:pt>
                <c:pt idx="3">
                  <c:v>-1.9167818612632381</c:v>
                </c:pt>
                <c:pt idx="4">
                  <c:v>-1.8823442496179872</c:v>
                </c:pt>
                <c:pt idx="5">
                  <c:v>-1.8707900570718738</c:v>
                </c:pt>
                <c:pt idx="6">
                  <c:v>-1.8585648089689399</c:v>
                </c:pt>
                <c:pt idx="7">
                  <c:v>-1.8448064506092692</c:v>
                </c:pt>
                <c:pt idx="8">
                  <c:v>-1.833250403195928</c:v>
                </c:pt>
                <c:pt idx="9">
                  <c:v>-1.818020050757702</c:v>
                </c:pt>
                <c:pt idx="10">
                  <c:v>-1.811594665642837</c:v>
                </c:pt>
                <c:pt idx="11">
                  <c:v>-1.7933324098269201</c:v>
                </c:pt>
                <c:pt idx="12">
                  <c:v>-1.7899060154717472</c:v>
                </c:pt>
                <c:pt idx="13">
                  <c:v>-1.782096203990023</c:v>
                </c:pt>
                <c:pt idx="14">
                  <c:v>-1.7670299039895436</c:v>
                </c:pt>
                <c:pt idx="15">
                  <c:v>-1.7670287237251419</c:v>
                </c:pt>
                <c:pt idx="16">
                  <c:v>-1.7645454218580565</c:v>
                </c:pt>
                <c:pt idx="17">
                  <c:v>-1.7432936382815059</c:v>
                </c:pt>
                <c:pt idx="18">
                  <c:v>-1.7360369286858941</c:v>
                </c:pt>
                <c:pt idx="19">
                  <c:v>-1.7282411987614636</c:v>
                </c:pt>
                <c:pt idx="20">
                  <c:v>-1.7085758918793492</c:v>
                </c:pt>
                <c:pt idx="21">
                  <c:v>-1.6975814295945055</c:v>
                </c:pt>
                <c:pt idx="22">
                  <c:v>-1.6966125022503262</c:v>
                </c:pt>
                <c:pt idx="23">
                  <c:v>-1.686075230390462</c:v>
                </c:pt>
                <c:pt idx="24">
                  <c:v>-1.6841055317314273</c:v>
                </c:pt>
                <c:pt idx="25">
                  <c:v>-1.6772433773814619</c:v>
                </c:pt>
                <c:pt idx="26">
                  <c:v>-1.6766476017359317</c:v>
                </c:pt>
                <c:pt idx="27">
                  <c:v>-1.6726368847681301</c:v>
                </c:pt>
                <c:pt idx="28">
                  <c:v>-1.6680077226355667</c:v>
                </c:pt>
                <c:pt idx="29">
                  <c:v>-1.6627855727179341</c:v>
                </c:pt>
                <c:pt idx="30">
                  <c:v>-1.6552912513758835</c:v>
                </c:pt>
                <c:pt idx="31">
                  <c:v>-1.6544149929439613</c:v>
                </c:pt>
                <c:pt idx="32">
                  <c:v>-1.647844226411437</c:v>
                </c:pt>
                <c:pt idx="33">
                  <c:v>-1.6426926542922442</c:v>
                </c:pt>
                <c:pt idx="34">
                  <c:v>-1.6415665235575241</c:v>
                </c:pt>
                <c:pt idx="35">
                  <c:v>-1.6414863481602064</c:v>
                </c:pt>
                <c:pt idx="36">
                  <c:v>-1.6381176988418469</c:v>
                </c:pt>
                <c:pt idx="37">
                  <c:v>-1.6357737168786493</c:v>
                </c:pt>
                <c:pt idx="38">
                  <c:v>-1.6353242840123834</c:v>
                </c:pt>
                <c:pt idx="39">
                  <c:v>-1.6334491736829013</c:v>
                </c:pt>
                <c:pt idx="40">
                  <c:v>-1.6321648054517421</c:v>
                </c:pt>
                <c:pt idx="41">
                  <c:v>-1.6292462766700426</c:v>
                </c:pt>
                <c:pt idx="42">
                  <c:v>-1.6244311033130701</c:v>
                </c:pt>
                <c:pt idx="43">
                  <c:v>-1.6236715569889573</c:v>
                </c:pt>
                <c:pt idx="44">
                  <c:v>-1.6192488950779864</c:v>
                </c:pt>
                <c:pt idx="45">
                  <c:v>-1.6184595750360229</c:v>
                </c:pt>
                <c:pt idx="46">
                  <c:v>-1.6166969459993279</c:v>
                </c:pt>
                <c:pt idx="47">
                  <c:v>-1.6140152458653481</c:v>
                </c:pt>
                <c:pt idx="48">
                  <c:v>-1.6112879226582495</c:v>
                </c:pt>
                <c:pt idx="49">
                  <c:v>-1.6107539370744379</c:v>
                </c:pt>
                <c:pt idx="50">
                  <c:v>-1.6106473790655191</c:v>
                </c:pt>
                <c:pt idx="51">
                  <c:v>-1.6087281688368349</c:v>
                </c:pt>
                <c:pt idx="52">
                  <c:v>-1.6086901131041378</c:v>
                </c:pt>
                <c:pt idx="53">
                  <c:v>-1.6016524183934471</c:v>
                </c:pt>
                <c:pt idx="54">
                  <c:v>-1.5984609608662816</c:v>
                </c:pt>
                <c:pt idx="55">
                  <c:v>-1.5979800841409064</c:v>
                </c:pt>
                <c:pt idx="56">
                  <c:v>-1.5955099770900558</c:v>
                </c:pt>
                <c:pt idx="57">
                  <c:v>-1.5883877495359762</c:v>
                </c:pt>
                <c:pt idx="58">
                  <c:v>-1.5786101257856466</c:v>
                </c:pt>
                <c:pt idx="59">
                  <c:v>-1.578365249041398</c:v>
                </c:pt>
                <c:pt idx="60">
                  <c:v>-1.5769177342044922</c:v>
                </c:pt>
                <c:pt idx="61">
                  <c:v>-1.576069281761304</c:v>
                </c:pt>
                <c:pt idx="62">
                  <c:v>-1.5734204351613619</c:v>
                </c:pt>
                <c:pt idx="63">
                  <c:v>-1.5732011700035542</c:v>
                </c:pt>
                <c:pt idx="64">
                  <c:v>-1.572087172195971</c:v>
                </c:pt>
                <c:pt idx="65">
                  <c:v>-1.5709043431448986</c:v>
                </c:pt>
                <c:pt idx="66">
                  <c:v>-1.5657771152320656</c:v>
                </c:pt>
                <c:pt idx="67">
                  <c:v>-1.5603577336682142</c:v>
                </c:pt>
                <c:pt idx="68">
                  <c:v>-1.5564126294486509</c:v>
                </c:pt>
                <c:pt idx="69">
                  <c:v>-1.5561614867990119</c:v>
                </c:pt>
                <c:pt idx="70">
                  <c:v>-1.5557441808944628</c:v>
                </c:pt>
                <c:pt idx="71">
                  <c:v>-1.5509710842441478</c:v>
                </c:pt>
                <c:pt idx="72">
                  <c:v>-1.5508661292667427</c:v>
                </c:pt>
                <c:pt idx="73">
                  <c:v>-1.5488726313710401</c:v>
                </c:pt>
                <c:pt idx="74">
                  <c:v>-1.5478565897991379</c:v>
                </c:pt>
                <c:pt idx="75">
                  <c:v>-1.5477858480776496</c:v>
                </c:pt>
                <c:pt idx="76">
                  <c:v>-1.5468436677389019</c:v>
                </c:pt>
                <c:pt idx="77">
                  <c:v>-1.5466535077386241</c:v>
                </c:pt>
                <c:pt idx="78">
                  <c:v>-1.5413167874990152</c:v>
                </c:pt>
                <c:pt idx="79">
                  <c:v>-1.5397389082286339</c:v>
                </c:pt>
                <c:pt idx="80">
                  <c:v>-1.5334161605005601</c:v>
                </c:pt>
                <c:pt idx="81">
                  <c:v>-1.5331015066154916</c:v>
                </c:pt>
                <c:pt idx="82">
                  <c:v>-1.5316382901699863</c:v>
                </c:pt>
                <c:pt idx="83">
                  <c:v>-1.5308037984385738</c:v>
                </c:pt>
                <c:pt idx="84">
                  <c:v>-1.5298061424301956</c:v>
                </c:pt>
                <c:pt idx="85">
                  <c:v>-1.5287219708215161</c:v>
                </c:pt>
                <c:pt idx="86">
                  <c:v>-1.5262369184497626</c:v>
                </c:pt>
                <c:pt idx="87">
                  <c:v>-1.5261893978577235</c:v>
                </c:pt>
                <c:pt idx="88">
                  <c:v>-1.5249577536759866</c:v>
                </c:pt>
                <c:pt idx="89">
                  <c:v>-1.5244689910918181</c:v>
                </c:pt>
                <c:pt idx="90">
                  <c:v>-1.5241492703266446</c:v>
                </c:pt>
                <c:pt idx="91">
                  <c:v>-1.5230807798455086</c:v>
                </c:pt>
                <c:pt idx="92">
                  <c:v>-1.5196880857224535</c:v>
                </c:pt>
                <c:pt idx="93">
                  <c:v>-1.5181341081262325</c:v>
                </c:pt>
                <c:pt idx="94">
                  <c:v>-1.5154651314758369</c:v>
                </c:pt>
                <c:pt idx="95">
                  <c:v>-1.5144522695923981</c:v>
                </c:pt>
                <c:pt idx="96">
                  <c:v>-1.5131597177956493</c:v>
                </c:pt>
                <c:pt idx="97">
                  <c:v>-1.5129665690655463</c:v>
                </c:pt>
                <c:pt idx="98">
                  <c:v>-1.5111875785458662</c:v>
                </c:pt>
                <c:pt idx="99">
                  <c:v>-1.5103462661233202</c:v>
                </c:pt>
                <c:pt idx="100">
                  <c:v>-1.5085517293340081</c:v>
                </c:pt>
                <c:pt idx="101">
                  <c:v>-1.508501726413098</c:v>
                </c:pt>
                <c:pt idx="102">
                  <c:v>-1.5084422929471653</c:v>
                </c:pt>
                <c:pt idx="103">
                  <c:v>-1.5078868885249666</c:v>
                </c:pt>
                <c:pt idx="104">
                  <c:v>-1.5074834266141466</c:v>
                </c:pt>
                <c:pt idx="105">
                  <c:v>-1.5058853054684878</c:v>
                </c:pt>
                <c:pt idx="106">
                  <c:v>-1.5053112974806535</c:v>
                </c:pt>
                <c:pt idx="107">
                  <c:v>-1.5043221688128021</c:v>
                </c:pt>
                <c:pt idx="108">
                  <c:v>-1.5027269008296844</c:v>
                </c:pt>
                <c:pt idx="109">
                  <c:v>-1.5015970445590994</c:v>
                </c:pt>
                <c:pt idx="110">
                  <c:v>1.5177976549999967</c:v>
                </c:pt>
                <c:pt idx="111">
                  <c:v>1.518076998</c:v>
                </c:pt>
                <c:pt idx="112">
                  <c:v>1.534008773</c:v>
                </c:pt>
                <c:pt idx="113">
                  <c:v>1.535262323</c:v>
                </c:pt>
                <c:pt idx="114">
                  <c:v>1.5583687159999973</c:v>
                </c:pt>
                <c:pt idx="115">
                  <c:v>1.7807168449999999</c:v>
                </c:pt>
                <c:pt idx="116">
                  <c:v>1.9694750290000032</c:v>
                </c:pt>
                <c:pt idx="117">
                  <c:v>1.9750962519999973</c:v>
                </c:pt>
              </c:numCache>
            </c:numRef>
          </c:xVal>
          <c:yVal>
            <c:numRef>
              <c:f>IPF1_Classifier!$E$2:$E$119</c:f>
              <c:numCache>
                <c:formatCode>General</c:formatCode>
                <c:ptCount val="118"/>
                <c:pt idx="0">
                  <c:v>-1.5401124750000001</c:v>
                </c:pt>
                <c:pt idx="1">
                  <c:v>-1.3527477640000038</c:v>
                </c:pt>
                <c:pt idx="2">
                  <c:v>-1.4648107519999998</c:v>
                </c:pt>
                <c:pt idx="3">
                  <c:v>-1.623298788999997</c:v>
                </c:pt>
                <c:pt idx="4">
                  <c:v>-1.5063650449999999</c:v>
                </c:pt>
                <c:pt idx="5">
                  <c:v>-1.630951958</c:v>
                </c:pt>
                <c:pt idx="6">
                  <c:v>-1.432181449</c:v>
                </c:pt>
                <c:pt idx="7">
                  <c:v>-1.8177362179999939</c:v>
                </c:pt>
                <c:pt idx="8">
                  <c:v>-1.4219366009999939</c:v>
                </c:pt>
                <c:pt idx="9">
                  <c:v>-1.152829031</c:v>
                </c:pt>
                <c:pt idx="10">
                  <c:v>-1.2503408439999999</c:v>
                </c:pt>
                <c:pt idx="11">
                  <c:v>-1.201189931</c:v>
                </c:pt>
                <c:pt idx="12">
                  <c:v>-1.4192990199999949</c:v>
                </c:pt>
                <c:pt idx="13">
                  <c:v>-1.050366535</c:v>
                </c:pt>
                <c:pt idx="14">
                  <c:v>-1.6267181270000026</c:v>
                </c:pt>
                <c:pt idx="15">
                  <c:v>-1.4131636749999967</c:v>
                </c:pt>
                <c:pt idx="16">
                  <c:v>-1.316571355999997</c:v>
                </c:pt>
                <c:pt idx="17">
                  <c:v>-1.219617344</c:v>
                </c:pt>
                <c:pt idx="18">
                  <c:v>-1.31217877</c:v>
                </c:pt>
                <c:pt idx="19">
                  <c:v>-1.3947436660000001</c:v>
                </c:pt>
                <c:pt idx="20">
                  <c:v>-1.3542555470000026</c:v>
                </c:pt>
                <c:pt idx="21">
                  <c:v>-1.3159196749999973</c:v>
                </c:pt>
                <c:pt idx="22">
                  <c:v>-1.2250640189999946</c:v>
                </c:pt>
                <c:pt idx="23">
                  <c:v>-1.644330157</c:v>
                </c:pt>
                <c:pt idx="24">
                  <c:v>-1.264816919</c:v>
                </c:pt>
                <c:pt idx="25">
                  <c:v>-1.3477339369999999</c:v>
                </c:pt>
                <c:pt idx="26">
                  <c:v>-1.3323088610000029</c:v>
                </c:pt>
                <c:pt idx="27">
                  <c:v>-1.300536728</c:v>
                </c:pt>
                <c:pt idx="28">
                  <c:v>-1.5236166929999941</c:v>
                </c:pt>
                <c:pt idx="29">
                  <c:v>1.0809662119999968</c:v>
                </c:pt>
                <c:pt idx="30">
                  <c:v>-1.2443196499999998</c:v>
                </c:pt>
                <c:pt idx="31">
                  <c:v>-1.436620065999997</c:v>
                </c:pt>
                <c:pt idx="32">
                  <c:v>-1.257168973</c:v>
                </c:pt>
                <c:pt idx="33">
                  <c:v>-1.3591253979999955</c:v>
                </c:pt>
                <c:pt idx="34">
                  <c:v>-1.506178604</c:v>
                </c:pt>
                <c:pt idx="35">
                  <c:v>-1.2394008449999998</c:v>
                </c:pt>
                <c:pt idx="36">
                  <c:v>-1.2081981999999998</c:v>
                </c:pt>
                <c:pt idx="37">
                  <c:v>-1.4476872849999998</c:v>
                </c:pt>
                <c:pt idx="38">
                  <c:v>-1.357612195</c:v>
                </c:pt>
                <c:pt idx="39">
                  <c:v>-1.5755907559999955</c:v>
                </c:pt>
                <c:pt idx="40">
                  <c:v>-1.351074418999997</c:v>
                </c:pt>
                <c:pt idx="41">
                  <c:v>-1.277087294</c:v>
                </c:pt>
                <c:pt idx="42">
                  <c:v>-1.3125036449999998</c:v>
                </c:pt>
                <c:pt idx="43">
                  <c:v>-1.2679518849999998</c:v>
                </c:pt>
                <c:pt idx="44">
                  <c:v>-1.1845061710000029</c:v>
                </c:pt>
                <c:pt idx="45">
                  <c:v>-1.257947251999997</c:v>
                </c:pt>
                <c:pt idx="46">
                  <c:v>-1.2620020780000001</c:v>
                </c:pt>
                <c:pt idx="47">
                  <c:v>-1.2953956979999943</c:v>
                </c:pt>
                <c:pt idx="48">
                  <c:v>-1.3120163650000001</c:v>
                </c:pt>
                <c:pt idx="49">
                  <c:v>-1.076693144</c:v>
                </c:pt>
                <c:pt idx="50">
                  <c:v>-1.3198345979999941</c:v>
                </c:pt>
                <c:pt idx="51">
                  <c:v>-1.397854583</c:v>
                </c:pt>
                <c:pt idx="52">
                  <c:v>-1.1552573640000043</c:v>
                </c:pt>
                <c:pt idx="53">
                  <c:v>-1.390778681</c:v>
                </c:pt>
                <c:pt idx="54">
                  <c:v>-1.300214816</c:v>
                </c:pt>
                <c:pt idx="55">
                  <c:v>-1.2387873640000029</c:v>
                </c:pt>
                <c:pt idx="56">
                  <c:v>-1.202677639</c:v>
                </c:pt>
                <c:pt idx="57">
                  <c:v>-1.3193445969999973</c:v>
                </c:pt>
                <c:pt idx="58">
                  <c:v>-1.34923613</c:v>
                </c:pt>
                <c:pt idx="59">
                  <c:v>-1.662338616</c:v>
                </c:pt>
                <c:pt idx="60">
                  <c:v>-1.364181605</c:v>
                </c:pt>
                <c:pt idx="61">
                  <c:v>-1.1188094040000001</c:v>
                </c:pt>
                <c:pt idx="62">
                  <c:v>-1.2274925640000001</c:v>
                </c:pt>
                <c:pt idx="63">
                  <c:v>-1.301664046999996</c:v>
                </c:pt>
                <c:pt idx="64">
                  <c:v>-1.442500109</c:v>
                </c:pt>
                <c:pt idx="65">
                  <c:v>-1.3300021440000032</c:v>
                </c:pt>
                <c:pt idx="66">
                  <c:v>-1.1435912039999963</c:v>
                </c:pt>
                <c:pt idx="67">
                  <c:v>-1.1833338410000001</c:v>
                </c:pt>
                <c:pt idx="68">
                  <c:v>-1.2114927029999956</c:v>
                </c:pt>
                <c:pt idx="69">
                  <c:v>-1.1977751800000001</c:v>
                </c:pt>
                <c:pt idx="70">
                  <c:v>-1.5117818769999998</c:v>
                </c:pt>
                <c:pt idx="71">
                  <c:v>-1.2638779419999999</c:v>
                </c:pt>
                <c:pt idx="72">
                  <c:v>-1.2357245059999946</c:v>
                </c:pt>
                <c:pt idx="73">
                  <c:v>-1.3763933779999973</c:v>
                </c:pt>
                <c:pt idx="74">
                  <c:v>-1.1585509000000032</c:v>
                </c:pt>
                <c:pt idx="75">
                  <c:v>-1.4334228769999973</c:v>
                </c:pt>
                <c:pt idx="76">
                  <c:v>-1.218410263</c:v>
                </c:pt>
                <c:pt idx="77">
                  <c:v>-1.3943984359999999</c:v>
                </c:pt>
                <c:pt idx="78">
                  <c:v>-1.2290128499999999</c:v>
                </c:pt>
                <c:pt idx="79">
                  <c:v>-1.183626813999997</c:v>
                </c:pt>
                <c:pt idx="80">
                  <c:v>-1.2775616009999946</c:v>
                </c:pt>
                <c:pt idx="81">
                  <c:v>-1.222488953</c:v>
                </c:pt>
                <c:pt idx="82">
                  <c:v>-1.2340431629999999</c:v>
                </c:pt>
                <c:pt idx="83">
                  <c:v>-1.1964416169999998</c:v>
                </c:pt>
                <c:pt idx="84">
                  <c:v>-1.304244443</c:v>
                </c:pt>
                <c:pt idx="85">
                  <c:v>-1.1079226349999998</c:v>
                </c:pt>
                <c:pt idx="86">
                  <c:v>-1.252044390999997</c:v>
                </c:pt>
                <c:pt idx="87">
                  <c:v>-1.3257288329999972</c:v>
                </c:pt>
                <c:pt idx="88">
                  <c:v>-1.1868543149999999</c:v>
                </c:pt>
                <c:pt idx="89">
                  <c:v>-1.3626627710000001</c:v>
                </c:pt>
                <c:pt idx="90">
                  <c:v>-1.2891575350000026</c:v>
                </c:pt>
                <c:pt idx="91">
                  <c:v>-1.248330548</c:v>
                </c:pt>
                <c:pt idx="92">
                  <c:v>-1.1777811010000001</c:v>
                </c:pt>
                <c:pt idx="93">
                  <c:v>-1.1354107339999999</c:v>
                </c:pt>
                <c:pt idx="94">
                  <c:v>-1.5112206129999943</c:v>
                </c:pt>
                <c:pt idx="95">
                  <c:v>-1.1666092579999965</c:v>
                </c:pt>
                <c:pt idx="96">
                  <c:v>-1.1777811010000001</c:v>
                </c:pt>
                <c:pt idx="97">
                  <c:v>-1.221279030999997</c:v>
                </c:pt>
                <c:pt idx="98">
                  <c:v>-1.3013418549999998</c:v>
                </c:pt>
                <c:pt idx="99">
                  <c:v>-1.144865859</c:v>
                </c:pt>
                <c:pt idx="100">
                  <c:v>-1.0979569039999999</c:v>
                </c:pt>
                <c:pt idx="101">
                  <c:v>-1.2652866699999998</c:v>
                </c:pt>
                <c:pt idx="102">
                  <c:v>-1.3222873380000029</c:v>
                </c:pt>
                <c:pt idx="103">
                  <c:v>-1.2384807360000001</c:v>
                </c:pt>
                <c:pt idx="104">
                  <c:v>-1.208946163</c:v>
                </c:pt>
                <c:pt idx="105">
                  <c:v>-1.3385901339999999</c:v>
                </c:pt>
                <c:pt idx="106">
                  <c:v>-1.2867662479999946</c:v>
                </c:pt>
                <c:pt idx="107">
                  <c:v>-1.3449010210000001</c:v>
                </c:pt>
                <c:pt idx="108">
                  <c:v>-1.2004467649999999</c:v>
                </c:pt>
                <c:pt idx="109">
                  <c:v>-1.308124630999997</c:v>
                </c:pt>
                <c:pt idx="110">
                  <c:v>1.547181937</c:v>
                </c:pt>
                <c:pt idx="111">
                  <c:v>1.556016267</c:v>
                </c:pt>
                <c:pt idx="112">
                  <c:v>1.051016787999997</c:v>
                </c:pt>
                <c:pt idx="113">
                  <c:v>1.021138511</c:v>
                </c:pt>
                <c:pt idx="114">
                  <c:v>1.2081981999999998</c:v>
                </c:pt>
                <c:pt idx="115">
                  <c:v>1.4748167579999956</c:v>
                </c:pt>
                <c:pt idx="116">
                  <c:v>1.1380840780000001</c:v>
                </c:pt>
                <c:pt idx="117">
                  <c:v>1.1282659260000041</c:v>
                </c:pt>
              </c:numCache>
            </c:numRef>
          </c:yVal>
        </c:ser>
        <c:ser>
          <c:idx val="1"/>
          <c:order val="1"/>
          <c:tx>
            <c:v>UPV cohort</c:v>
          </c:tx>
          <c:spPr>
            <a:ln w="28575">
              <a:noFill/>
            </a:ln>
          </c:spPr>
          <c:marker>
            <c:symbol val="triangle"/>
            <c:size val="2"/>
          </c:marker>
          <c:trendline>
            <c:trendlineType val="linear"/>
            <c:dispRSqr val="1"/>
            <c:dispEq val="1"/>
            <c:trendlineLbl>
              <c:layout>
                <c:manualLayout>
                  <c:x val="-0.46700787401574884"/>
                  <c:y val="-0.16943106376408831"/>
                </c:manualLayout>
              </c:layout>
              <c:tx>
                <c:rich>
                  <a:bodyPr/>
                  <a:lstStyle/>
                  <a:p>
                    <a:pPr>
                      <a:defRPr>
                        <a:latin typeface="Times New Roman" pitchFamily="18" charset="0"/>
                        <a:cs typeface="Times New Roman" pitchFamily="18" charset="0"/>
                      </a:defRPr>
                    </a:pPr>
                    <a:r>
                      <a:rPr lang="en-US" baseline="0" dirty="0" smtClean="0"/>
                      <a:t>R² </a:t>
                    </a:r>
                    <a:r>
                      <a:rPr lang="en-US" baseline="0" dirty="0"/>
                      <a:t>= </a:t>
                    </a:r>
                    <a:r>
                      <a:rPr lang="en-US" baseline="0" dirty="0" smtClean="0"/>
                      <a:t>0.58</a:t>
                    </a:r>
                    <a:endParaRPr lang="en-US" dirty="0"/>
                  </a:p>
                </c:rich>
              </c:tx>
              <c:numFmt formatCode="General" sourceLinked="0"/>
            </c:trendlineLbl>
          </c:trendline>
          <c:xVal>
            <c:numRef>
              <c:f>IPF1_Classifier!$M$2:$M$109</c:f>
              <c:numCache>
                <c:formatCode>General</c:formatCode>
                <c:ptCount val="108"/>
                <c:pt idx="0">
                  <c:v>1.9694750290000032</c:v>
                </c:pt>
                <c:pt idx="1">
                  <c:v>1.7807168449999999</c:v>
                </c:pt>
                <c:pt idx="2">
                  <c:v>1.5583687159999973</c:v>
                </c:pt>
                <c:pt idx="3">
                  <c:v>1.5177976549999967</c:v>
                </c:pt>
                <c:pt idx="4">
                  <c:v>-1.555744180999997</c:v>
                </c:pt>
                <c:pt idx="5">
                  <c:v>-1.6236715569999998</c:v>
                </c:pt>
                <c:pt idx="6">
                  <c:v>-1.7360369290000026</c:v>
                </c:pt>
                <c:pt idx="7">
                  <c:v>-1.6975814300000001</c:v>
                </c:pt>
                <c:pt idx="8">
                  <c:v>1.9750962519999973</c:v>
                </c:pt>
                <c:pt idx="9">
                  <c:v>-1.5316382899999967</c:v>
                </c:pt>
                <c:pt idx="10">
                  <c:v>1.535262323</c:v>
                </c:pt>
                <c:pt idx="11">
                  <c:v>-1.6192488949999999</c:v>
                </c:pt>
                <c:pt idx="12">
                  <c:v>-1.5734204349999998</c:v>
                </c:pt>
                <c:pt idx="13">
                  <c:v>-1.5564126290000029</c:v>
                </c:pt>
                <c:pt idx="14">
                  <c:v>-1.5230807799999999</c:v>
                </c:pt>
                <c:pt idx="15">
                  <c:v>-1.7933324099999999</c:v>
                </c:pt>
                <c:pt idx="16">
                  <c:v>-1.858564809</c:v>
                </c:pt>
                <c:pt idx="17">
                  <c:v>-1.6107539370000001</c:v>
                </c:pt>
                <c:pt idx="18">
                  <c:v>-1.512966569</c:v>
                </c:pt>
                <c:pt idx="19">
                  <c:v>-1.6140152459999999</c:v>
                </c:pt>
                <c:pt idx="20">
                  <c:v>-1.672636885</c:v>
                </c:pt>
                <c:pt idx="21">
                  <c:v>-1.818020051</c:v>
                </c:pt>
                <c:pt idx="22">
                  <c:v>-1.9469720090000029</c:v>
                </c:pt>
                <c:pt idx="23">
                  <c:v>-1.5196880859999973</c:v>
                </c:pt>
                <c:pt idx="24">
                  <c:v>-1.51445227</c:v>
                </c:pt>
                <c:pt idx="25">
                  <c:v>-1.6627855730000038</c:v>
                </c:pt>
                <c:pt idx="26">
                  <c:v>-1.6552912509999949</c:v>
                </c:pt>
                <c:pt idx="27">
                  <c:v>-1.5308037979999956</c:v>
                </c:pt>
                <c:pt idx="28">
                  <c:v>-1.528721971</c:v>
                </c:pt>
                <c:pt idx="29">
                  <c:v>-1.8115946659999949</c:v>
                </c:pt>
                <c:pt idx="30">
                  <c:v>-1.5603577340000043</c:v>
                </c:pt>
                <c:pt idx="31">
                  <c:v>-1.5709043429999963</c:v>
                </c:pt>
                <c:pt idx="32">
                  <c:v>-1.5955099769999999</c:v>
                </c:pt>
                <c:pt idx="33">
                  <c:v>-1.6292462769999998</c:v>
                </c:pt>
                <c:pt idx="34">
                  <c:v>-1.9800517740000041</c:v>
                </c:pt>
                <c:pt idx="35">
                  <c:v>-1.524468991</c:v>
                </c:pt>
                <c:pt idx="36">
                  <c:v>-1.5413167869999973</c:v>
                </c:pt>
                <c:pt idx="37">
                  <c:v>-1.5249577540000001</c:v>
                </c:pt>
                <c:pt idx="38">
                  <c:v>-1.5085517289999999</c:v>
                </c:pt>
                <c:pt idx="39">
                  <c:v>1.534008773</c:v>
                </c:pt>
                <c:pt idx="40">
                  <c:v>-1.5181341079999973</c:v>
                </c:pt>
                <c:pt idx="41">
                  <c:v>-1.547785848</c:v>
                </c:pt>
                <c:pt idx="42">
                  <c:v>-1.6414863479999973</c:v>
                </c:pt>
                <c:pt idx="43">
                  <c:v>-1.5468436679999973</c:v>
                </c:pt>
                <c:pt idx="44">
                  <c:v>-1.7670299039999973</c:v>
                </c:pt>
                <c:pt idx="45">
                  <c:v>-1.5509710839999973</c:v>
                </c:pt>
                <c:pt idx="46">
                  <c:v>-1.5331015069999998</c:v>
                </c:pt>
                <c:pt idx="47">
                  <c:v>-1.5508661290000001</c:v>
                </c:pt>
                <c:pt idx="48">
                  <c:v>-1.5027269009999973</c:v>
                </c:pt>
                <c:pt idx="49">
                  <c:v>-1.6966125020000031</c:v>
                </c:pt>
                <c:pt idx="50">
                  <c:v>-1.5053112969999953</c:v>
                </c:pt>
                <c:pt idx="51">
                  <c:v>-1.5262369179999973</c:v>
                </c:pt>
                <c:pt idx="52">
                  <c:v>-1.616696946</c:v>
                </c:pt>
                <c:pt idx="53">
                  <c:v>-1.5466535079999999</c:v>
                </c:pt>
                <c:pt idx="54">
                  <c:v>-1.9171329850000001</c:v>
                </c:pt>
                <c:pt idx="55">
                  <c:v>-1.597980084</c:v>
                </c:pt>
                <c:pt idx="56">
                  <c:v>-1.5015970449999998</c:v>
                </c:pt>
                <c:pt idx="57">
                  <c:v>-1.5058853049999998</c:v>
                </c:pt>
                <c:pt idx="58">
                  <c:v>-1.6321648049999999</c:v>
                </c:pt>
                <c:pt idx="59">
                  <c:v>-1.5131597179999965</c:v>
                </c:pt>
                <c:pt idx="60">
                  <c:v>-1.5043221689999999</c:v>
                </c:pt>
                <c:pt idx="61">
                  <c:v>-1.515465131</c:v>
                </c:pt>
                <c:pt idx="62">
                  <c:v>-1.507886888999997</c:v>
                </c:pt>
                <c:pt idx="63">
                  <c:v>-1.508442292999997</c:v>
                </c:pt>
                <c:pt idx="64">
                  <c:v>-1.6381176989999999</c:v>
                </c:pt>
                <c:pt idx="65">
                  <c:v>-1.608690113</c:v>
                </c:pt>
                <c:pt idx="66">
                  <c:v>-1.5478565899999999</c:v>
                </c:pt>
                <c:pt idx="67">
                  <c:v>-1.539738907999997</c:v>
                </c:pt>
                <c:pt idx="68">
                  <c:v>-1.6766476020000001</c:v>
                </c:pt>
                <c:pt idx="69">
                  <c:v>-1.5298061419999998</c:v>
                </c:pt>
                <c:pt idx="70">
                  <c:v>-1.624431103</c:v>
                </c:pt>
                <c:pt idx="71">
                  <c:v>-1.601652418</c:v>
                </c:pt>
                <c:pt idx="72">
                  <c:v>-1.5769177340000029</c:v>
                </c:pt>
                <c:pt idx="73">
                  <c:v>-1.508501726</c:v>
                </c:pt>
                <c:pt idx="74">
                  <c:v>-1.6544149930000001</c:v>
                </c:pt>
                <c:pt idx="75">
                  <c:v>-1.6772433769999999</c:v>
                </c:pt>
                <c:pt idx="76">
                  <c:v>-1.7085758919999998</c:v>
                </c:pt>
                <c:pt idx="77">
                  <c:v>-1.6353242839999949</c:v>
                </c:pt>
                <c:pt idx="78">
                  <c:v>-1.642692654</c:v>
                </c:pt>
                <c:pt idx="79">
                  <c:v>-1.510346266</c:v>
                </c:pt>
                <c:pt idx="80">
                  <c:v>-1.767028724</c:v>
                </c:pt>
                <c:pt idx="81">
                  <c:v>-1.6334491739999999</c:v>
                </c:pt>
                <c:pt idx="82">
                  <c:v>-1.6357737169999973</c:v>
                </c:pt>
                <c:pt idx="83">
                  <c:v>-1.5657771149999999</c:v>
                </c:pt>
                <c:pt idx="84">
                  <c:v>-1.5561614869999998</c:v>
                </c:pt>
                <c:pt idx="85">
                  <c:v>-1.789906014999997</c:v>
                </c:pt>
                <c:pt idx="86">
                  <c:v>-1.728241199</c:v>
                </c:pt>
                <c:pt idx="87">
                  <c:v>-1.526189397999997</c:v>
                </c:pt>
                <c:pt idx="88">
                  <c:v>-1.6087281689999999</c:v>
                </c:pt>
                <c:pt idx="89">
                  <c:v>-1.6841055320000029</c:v>
                </c:pt>
                <c:pt idx="90">
                  <c:v>-1.7645454220000001</c:v>
                </c:pt>
                <c:pt idx="91">
                  <c:v>-1.5732011699999999</c:v>
                </c:pt>
                <c:pt idx="92">
                  <c:v>-1.5111875790000029</c:v>
                </c:pt>
                <c:pt idx="93">
                  <c:v>-1.6184595750000021</c:v>
                </c:pt>
                <c:pt idx="94">
                  <c:v>-1.5883877500000001</c:v>
                </c:pt>
                <c:pt idx="95">
                  <c:v>-1.6106473790000029</c:v>
                </c:pt>
                <c:pt idx="96">
                  <c:v>-1.8823442499999998</c:v>
                </c:pt>
                <c:pt idx="97">
                  <c:v>-1.5984609610000029</c:v>
                </c:pt>
                <c:pt idx="98">
                  <c:v>-1.8707900569999998</c:v>
                </c:pt>
                <c:pt idx="99">
                  <c:v>-1.5786101260000032</c:v>
                </c:pt>
                <c:pt idx="100">
                  <c:v>-1.647844225999997</c:v>
                </c:pt>
                <c:pt idx="101">
                  <c:v>-1.9167818610000031</c:v>
                </c:pt>
                <c:pt idx="102">
                  <c:v>-1.6415665239999999</c:v>
                </c:pt>
                <c:pt idx="103">
                  <c:v>-1.6112879230000043</c:v>
                </c:pt>
                <c:pt idx="104">
                  <c:v>-1.6860752300000001</c:v>
                </c:pt>
                <c:pt idx="105">
                  <c:v>-1.5720871720000031</c:v>
                </c:pt>
                <c:pt idx="106">
                  <c:v>-1.8332504030000001</c:v>
                </c:pt>
                <c:pt idx="107">
                  <c:v>-1.844806451</c:v>
                </c:pt>
              </c:numCache>
            </c:numRef>
          </c:xVal>
          <c:yVal>
            <c:numRef>
              <c:f>IPF1_Classifier!$N$2:$N$109</c:f>
              <c:numCache>
                <c:formatCode>General</c:formatCode>
                <c:ptCount val="108"/>
                <c:pt idx="0">
                  <c:v>2.5856636759999998</c:v>
                </c:pt>
                <c:pt idx="1">
                  <c:v>1.5724362119999973</c:v>
                </c:pt>
                <c:pt idx="2">
                  <c:v>1.250374259999997</c:v>
                </c:pt>
                <c:pt idx="3">
                  <c:v>1.232906601999997</c:v>
                </c:pt>
                <c:pt idx="4">
                  <c:v>1.1525999629999999</c:v>
                </c:pt>
                <c:pt idx="5">
                  <c:v>1.126020858</c:v>
                </c:pt>
                <c:pt idx="6">
                  <c:v>1.0989828320000001</c:v>
                </c:pt>
                <c:pt idx="7">
                  <c:v>1.0891524079999999</c:v>
                </c:pt>
                <c:pt idx="8">
                  <c:v>1.0815459869999999</c:v>
                </c:pt>
                <c:pt idx="9">
                  <c:v>1.0686714319999999</c:v>
                </c:pt>
                <c:pt idx="10">
                  <c:v>1.05787856</c:v>
                </c:pt>
                <c:pt idx="11">
                  <c:v>1.054343885</c:v>
                </c:pt>
                <c:pt idx="12">
                  <c:v>1.0400356829999973</c:v>
                </c:pt>
                <c:pt idx="13">
                  <c:v>1.0290170409999999</c:v>
                </c:pt>
                <c:pt idx="14">
                  <c:v>1.0260279480000001</c:v>
                </c:pt>
                <c:pt idx="15">
                  <c:v>1.0216124660000001</c:v>
                </c:pt>
                <c:pt idx="16">
                  <c:v>1.0199415469999973</c:v>
                </c:pt>
                <c:pt idx="17">
                  <c:v>1.0163263919999967</c:v>
                </c:pt>
                <c:pt idx="18">
                  <c:v>1.007660526</c:v>
                </c:pt>
                <c:pt idx="19">
                  <c:v>1.0047774700000001</c:v>
                </c:pt>
                <c:pt idx="20">
                  <c:v>1.000505637999997</c:v>
                </c:pt>
                <c:pt idx="21">
                  <c:v>-1.0033260299999998</c:v>
                </c:pt>
                <c:pt idx="22">
                  <c:v>-1.0085819709999999</c:v>
                </c:pt>
                <c:pt idx="23">
                  <c:v>-1.009264862999997</c:v>
                </c:pt>
                <c:pt idx="24">
                  <c:v>-1.013223414999997</c:v>
                </c:pt>
                <c:pt idx="25">
                  <c:v>-1.015957086</c:v>
                </c:pt>
                <c:pt idx="26">
                  <c:v>-1.019737871</c:v>
                </c:pt>
                <c:pt idx="27">
                  <c:v>-1.0210880519999999</c:v>
                </c:pt>
                <c:pt idx="28">
                  <c:v>-1.0218940789999948</c:v>
                </c:pt>
                <c:pt idx="29">
                  <c:v>-1.0228471560000001</c:v>
                </c:pt>
                <c:pt idx="30">
                  <c:v>-1.024581393999997</c:v>
                </c:pt>
                <c:pt idx="31">
                  <c:v>-1.0247148819999998</c:v>
                </c:pt>
                <c:pt idx="32">
                  <c:v>-1.0376369759999973</c:v>
                </c:pt>
                <c:pt idx="33">
                  <c:v>-1.041032682999997</c:v>
                </c:pt>
                <c:pt idx="34">
                  <c:v>-1.042181802</c:v>
                </c:pt>
                <c:pt idx="35">
                  <c:v>-1.0422390559999972</c:v>
                </c:pt>
                <c:pt idx="36">
                  <c:v>-1.0441970469999999</c:v>
                </c:pt>
                <c:pt idx="37">
                  <c:v>-1.0442252359999973</c:v>
                </c:pt>
                <c:pt idx="38">
                  <c:v>-1.0485092569999968</c:v>
                </c:pt>
                <c:pt idx="39">
                  <c:v>-1.0505108610000031</c:v>
                </c:pt>
                <c:pt idx="40">
                  <c:v>-1.0578689049999999</c:v>
                </c:pt>
                <c:pt idx="41">
                  <c:v>-1.064681698999997</c:v>
                </c:pt>
                <c:pt idx="42">
                  <c:v>-1.0735046349999973</c:v>
                </c:pt>
                <c:pt idx="43">
                  <c:v>-1.0745017579999963</c:v>
                </c:pt>
                <c:pt idx="44">
                  <c:v>-1.0746662529999949</c:v>
                </c:pt>
                <c:pt idx="45">
                  <c:v>-1.075120813999997</c:v>
                </c:pt>
                <c:pt idx="46">
                  <c:v>-1.076006003</c:v>
                </c:pt>
                <c:pt idx="47">
                  <c:v>-1.0767578550000001</c:v>
                </c:pt>
                <c:pt idx="48">
                  <c:v>-1.0772055629999999</c:v>
                </c:pt>
                <c:pt idx="49">
                  <c:v>-1.0784516159999973</c:v>
                </c:pt>
                <c:pt idx="50">
                  <c:v>-1.0807103240000029</c:v>
                </c:pt>
                <c:pt idx="51">
                  <c:v>-1.087792756999997</c:v>
                </c:pt>
                <c:pt idx="52">
                  <c:v>-1.0884809890000029</c:v>
                </c:pt>
                <c:pt idx="53">
                  <c:v>-1.0891780849999999</c:v>
                </c:pt>
                <c:pt idx="54">
                  <c:v>-1.0908438840000001</c:v>
                </c:pt>
                <c:pt idx="55">
                  <c:v>-1.0917501300000001</c:v>
                </c:pt>
                <c:pt idx="56">
                  <c:v>-1.0944507200000029</c:v>
                </c:pt>
                <c:pt idx="57">
                  <c:v>-1.0964473750000001</c:v>
                </c:pt>
                <c:pt idx="58">
                  <c:v>-1.0965166399999999</c:v>
                </c:pt>
                <c:pt idx="59">
                  <c:v>-1.1010346289999973</c:v>
                </c:pt>
                <c:pt idx="60">
                  <c:v>-1.1034294139999965</c:v>
                </c:pt>
                <c:pt idx="61">
                  <c:v>-1.104251407</c:v>
                </c:pt>
                <c:pt idx="62">
                  <c:v>-1.1078124110000001</c:v>
                </c:pt>
                <c:pt idx="63">
                  <c:v>-1.1108008789999999</c:v>
                </c:pt>
                <c:pt idx="64">
                  <c:v>-1.112970244</c:v>
                </c:pt>
                <c:pt idx="65">
                  <c:v>-1.1222551330000043</c:v>
                </c:pt>
                <c:pt idx="66">
                  <c:v>-1.1245621220000026</c:v>
                </c:pt>
                <c:pt idx="67">
                  <c:v>-1.126385395</c:v>
                </c:pt>
                <c:pt idx="68">
                  <c:v>-1.1269293459999965</c:v>
                </c:pt>
                <c:pt idx="69">
                  <c:v>-1.1278441579999965</c:v>
                </c:pt>
                <c:pt idx="70">
                  <c:v>-1.127850658999997</c:v>
                </c:pt>
                <c:pt idx="71">
                  <c:v>-1.135035359</c:v>
                </c:pt>
                <c:pt idx="72">
                  <c:v>-1.1532415690000026</c:v>
                </c:pt>
                <c:pt idx="73">
                  <c:v>-1.161371487999997</c:v>
                </c:pt>
                <c:pt idx="74">
                  <c:v>-1.166127417</c:v>
                </c:pt>
                <c:pt idx="75">
                  <c:v>-1.1678611859999972</c:v>
                </c:pt>
                <c:pt idx="76">
                  <c:v>-1.1724456910000001</c:v>
                </c:pt>
                <c:pt idx="77">
                  <c:v>-1.1739731949999999</c:v>
                </c:pt>
                <c:pt idx="78">
                  <c:v>-1.1778503010000001</c:v>
                </c:pt>
                <c:pt idx="79">
                  <c:v>-1.177913338</c:v>
                </c:pt>
                <c:pt idx="80">
                  <c:v>-1.1822490750000001</c:v>
                </c:pt>
                <c:pt idx="81">
                  <c:v>-1.1840387379999999</c:v>
                </c:pt>
                <c:pt idx="82">
                  <c:v>-1.1877183519999999</c:v>
                </c:pt>
                <c:pt idx="83">
                  <c:v>-1.1905749430000001</c:v>
                </c:pt>
                <c:pt idx="84">
                  <c:v>-1.1932419409999999</c:v>
                </c:pt>
                <c:pt idx="85">
                  <c:v>-1.1947751350000029</c:v>
                </c:pt>
                <c:pt idx="86">
                  <c:v>-1.1957824779999999</c:v>
                </c:pt>
                <c:pt idx="87">
                  <c:v>-1.1960907540000001</c:v>
                </c:pt>
                <c:pt idx="88">
                  <c:v>-1.200266407999997</c:v>
                </c:pt>
                <c:pt idx="89">
                  <c:v>-1.2046376599999973</c:v>
                </c:pt>
                <c:pt idx="90">
                  <c:v>-1.2097678349999998</c:v>
                </c:pt>
                <c:pt idx="91">
                  <c:v>-1.2103105670000001</c:v>
                </c:pt>
                <c:pt idx="92">
                  <c:v>-1.2266743859999956</c:v>
                </c:pt>
                <c:pt idx="93">
                  <c:v>-1.2292695749999998</c:v>
                </c:pt>
                <c:pt idx="94">
                  <c:v>-1.239549263999997</c:v>
                </c:pt>
                <c:pt idx="95">
                  <c:v>-1.241066591999997</c:v>
                </c:pt>
                <c:pt idx="96">
                  <c:v>-1.2449264719999973</c:v>
                </c:pt>
                <c:pt idx="97">
                  <c:v>-1.249742575</c:v>
                </c:pt>
                <c:pt idx="98">
                  <c:v>-1.253067095999997</c:v>
                </c:pt>
                <c:pt idx="99">
                  <c:v>-1.256479619999997</c:v>
                </c:pt>
                <c:pt idx="100">
                  <c:v>-1.2573247919999941</c:v>
                </c:pt>
                <c:pt idx="101">
                  <c:v>-1.2591242259999949</c:v>
                </c:pt>
                <c:pt idx="102">
                  <c:v>-1.2649357719999998</c:v>
                </c:pt>
                <c:pt idx="103">
                  <c:v>-1.2778547019999973</c:v>
                </c:pt>
                <c:pt idx="104">
                  <c:v>-1.293687437</c:v>
                </c:pt>
                <c:pt idx="105">
                  <c:v>-1.3703639400000001</c:v>
                </c:pt>
                <c:pt idx="106">
                  <c:v>-1.440740049</c:v>
                </c:pt>
                <c:pt idx="107">
                  <c:v>-1.4451474719999999</c:v>
                </c:pt>
              </c:numCache>
            </c:numRef>
          </c:yVal>
        </c:ser>
        <c:axId val="84543744"/>
        <c:axId val="84967808"/>
      </c:scatterChart>
      <c:valAx>
        <c:axId val="84543744"/>
        <c:scaling>
          <c:orientation val="minMax"/>
        </c:scaling>
        <c:axPos val="b"/>
        <c:numFmt formatCode="General" sourceLinked="1"/>
        <c:tickLblPos val="nextTo"/>
        <c:crossAx val="84967808"/>
        <c:crosses val="autoZero"/>
        <c:crossBetween val="midCat"/>
      </c:valAx>
      <c:valAx>
        <c:axId val="84967808"/>
        <c:scaling>
          <c:orientation val="minMax"/>
        </c:scaling>
        <c:axPos val="l"/>
        <c:majorGridlines/>
        <c:numFmt formatCode="General" sourceLinked="1"/>
        <c:tickLblPos val="nextTo"/>
        <c:crossAx val="84543744"/>
        <c:crosses val="autoZero"/>
        <c:crossBetween val="midCat"/>
      </c:valAx>
    </c:plotArea>
    <c:legend>
      <c:legendPos val="r"/>
      <c:legendEntry>
        <c:idx val="2"/>
        <c:delete val="1"/>
      </c:legendEntry>
      <c:legendEntry>
        <c:idx val="3"/>
        <c:delete val="1"/>
      </c:legendEntry>
      <c:layout>
        <c:manualLayout>
          <c:xMode val="edge"/>
          <c:yMode val="edge"/>
          <c:x val="0"/>
          <c:y val="2.0649992280376843E-3"/>
          <c:w val="0.42976287446827782"/>
          <c:h val="0.14292457928053112"/>
        </c:manualLayout>
      </c:layout>
      <c:txPr>
        <a:bodyPr/>
        <a:lstStyle/>
        <a:p>
          <a:pPr>
            <a:defRPr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</c:chart>
  <c:spPr>
    <a:noFill/>
    <a:ln>
      <a:noFill/>
    </a:ln>
  </c:sp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BE38C-A3B1-4177-A727-9A979ACAF589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E965A-19CA-422C-A760-972F973AB7A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BE38C-A3B1-4177-A727-9A979ACAF589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E965A-19CA-422C-A760-972F973AB7A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BE38C-A3B1-4177-A727-9A979ACAF589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E965A-19CA-422C-A760-972F973AB7A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BE38C-A3B1-4177-A727-9A979ACAF589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E965A-19CA-422C-A760-972F973AB7A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BE38C-A3B1-4177-A727-9A979ACAF589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E965A-19CA-422C-A760-972F973AB7A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BE38C-A3B1-4177-A727-9A979ACAF589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E965A-19CA-422C-A760-972F973AB7A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BE38C-A3B1-4177-A727-9A979ACAF589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E965A-19CA-422C-A760-972F973AB7A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BE38C-A3B1-4177-A727-9A979ACAF589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E965A-19CA-422C-A760-972F973AB7A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BE38C-A3B1-4177-A727-9A979ACAF589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E965A-19CA-422C-A760-972F973AB7A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BE38C-A3B1-4177-A727-9A979ACAF589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E965A-19CA-422C-A760-972F973AB7A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BE38C-A3B1-4177-A727-9A979ACAF589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E965A-19CA-422C-A760-972F973AB7A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ABE38C-A3B1-4177-A727-9A979ACAF589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6E965A-19CA-422C-A760-972F973AB7A5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0"/>
          <p:cNvSpPr txBox="1">
            <a:spLocks noChangeArrowheads="1"/>
          </p:cNvSpPr>
          <p:nvPr/>
        </p:nvSpPr>
        <p:spPr bwMode="auto">
          <a:xfrm rot="16200000">
            <a:off x="716583" y="2144123"/>
            <a:ext cx="231826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Fold change of genes in validation cohort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1"/>
          <p:cNvSpPr txBox="1">
            <a:spLocks noChangeArrowheads="1"/>
          </p:cNvSpPr>
          <p:nvPr/>
        </p:nvSpPr>
        <p:spPr bwMode="auto">
          <a:xfrm>
            <a:off x="3124200" y="3505202"/>
            <a:ext cx="220445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Fold change of genes in training</a:t>
            </a:r>
            <a:r>
              <a:rPr lang="en-US" sz="10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ohort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914400" y="609603"/>
            <a:ext cx="819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3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6" name="Chart 5"/>
          <p:cNvGraphicFramePr/>
          <p:nvPr/>
        </p:nvGraphicFramePr>
        <p:xfrm>
          <a:off x="1905000" y="990600"/>
          <a:ext cx="4419600" cy="2590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hwu-Fan Ma</dc:creator>
  <cp:lastModifiedBy>Shwu-Fan Ma</cp:lastModifiedBy>
  <cp:revision>1</cp:revision>
  <dcterms:created xsi:type="dcterms:W3CDTF">2015-11-10T20:16:58Z</dcterms:created>
  <dcterms:modified xsi:type="dcterms:W3CDTF">2015-11-10T20:17:48Z</dcterms:modified>
</cp:coreProperties>
</file>